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D997B-78A8-4CA3-BFF6-F0FEFA3E43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5B7B0-014E-4000-9EF9-8DC46751F2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0FFF2-8558-4A8B-8065-F11B0F107F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E3F2C-18A1-47C3-87E4-2206CD7E46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E2689-7358-4F09-A79F-8FECDFB643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AAA98-AAF8-4C2B-82AD-035EA2F60B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DF95E-1A63-436F-B332-A6BC775DB4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61945-C3AA-4374-970B-2739EA1AFB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809DB6-D39F-4504-8078-D7DFE1E649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22E23-0795-4750-A0B9-47A667BFD0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004FA-4CCC-4322-939F-3FF5ABFA47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1A4FA3-7309-4EF7-B840-D63052673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AA5CD6-AE21-4ACA-B5B9-83F8EC74FD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49480" y="8604360"/>
            <a:ext cx="280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ix et al., Additional data file 3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321360" y="127476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240000" y="1344600"/>
            <a:ext cx="76320" cy="101520"/>
          </a:xfrm>
          <a:custGeom>
            <a:avLst/>
            <a:gdLst/>
            <a:ahLst/>
            <a:rect l="l" t="t" r="r" b="b"/>
            <a:pathLst>
              <a:path w="49" h="64">
                <a:moveTo>
                  <a:pt x="0" y="64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278520" y="148608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240000" y="1455840"/>
            <a:ext cx="34920" cy="100080"/>
          </a:xfrm>
          <a:custGeom>
            <a:avLst/>
            <a:gdLst/>
            <a:ahLst/>
            <a:rect l="l" t="t" r="r" b="b"/>
            <a:pathLst>
              <a:path w="23" h="63">
                <a:moveTo>
                  <a:pt x="0" y="0"/>
                </a:moveTo>
                <a:lnTo>
                  <a:pt x="0" y="63"/>
                </a:lnTo>
                <a:lnTo>
                  <a:pt x="23" y="6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919240" y="1450800"/>
            <a:ext cx="320760" cy="285840"/>
          </a:xfrm>
          <a:custGeom>
            <a:avLst/>
            <a:gdLst/>
            <a:ahLst/>
            <a:rect l="l" t="t" r="r" b="b"/>
            <a:pathLst>
              <a:path w="201" h="180">
                <a:moveTo>
                  <a:pt x="0" y="180"/>
                </a:moveTo>
                <a:lnTo>
                  <a:pt x="0" y="0"/>
                </a:lnTo>
                <a:lnTo>
                  <a:pt x="201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610440" y="169704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106800" y="1766880"/>
            <a:ext cx="501480" cy="101520"/>
          </a:xfrm>
          <a:custGeom>
            <a:avLst/>
            <a:gdLst/>
            <a:ahLst/>
            <a:rect l="l" t="t" r="r" b="b"/>
            <a:pathLst>
              <a:path w="316" h="64">
                <a:moveTo>
                  <a:pt x="0" y="64"/>
                </a:moveTo>
                <a:lnTo>
                  <a:pt x="0" y="0"/>
                </a:lnTo>
                <a:lnTo>
                  <a:pt x="316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085280" y="19080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106800" y="1878120"/>
            <a:ext cx="977760" cy="100080"/>
          </a:xfrm>
          <a:custGeom>
            <a:avLst/>
            <a:gdLst/>
            <a:ahLst/>
            <a:rect l="l" t="t" r="r" b="b"/>
            <a:pathLst>
              <a:path w="616" h="63">
                <a:moveTo>
                  <a:pt x="0" y="0"/>
                </a:moveTo>
                <a:lnTo>
                  <a:pt x="0" y="63"/>
                </a:lnTo>
                <a:lnTo>
                  <a:pt x="616" y="6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017880" y="1873080"/>
            <a:ext cx="88920" cy="154080"/>
          </a:xfrm>
          <a:custGeom>
            <a:avLst/>
            <a:gdLst/>
            <a:ahLst/>
            <a:rect l="l" t="t" r="r" b="b"/>
            <a:pathLst>
              <a:path w="55" h="97">
                <a:moveTo>
                  <a:pt x="0" y="97"/>
                </a:moveTo>
                <a:lnTo>
                  <a:pt x="0" y="0"/>
                </a:lnTo>
                <a:lnTo>
                  <a:pt x="55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387960" y="21207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017880" y="2035080"/>
            <a:ext cx="368280" cy="155520"/>
          </a:xfrm>
          <a:custGeom>
            <a:avLst/>
            <a:gdLst/>
            <a:ahLst/>
            <a:rect l="l" t="t" r="r" b="b"/>
            <a:pathLst>
              <a:path w="231" h="98">
                <a:moveTo>
                  <a:pt x="0" y="0"/>
                </a:moveTo>
                <a:lnTo>
                  <a:pt x="0" y="98"/>
                </a:lnTo>
                <a:lnTo>
                  <a:pt x="231" y="98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919240" y="1746360"/>
            <a:ext cx="98640" cy="285480"/>
          </a:xfrm>
          <a:custGeom>
            <a:avLst/>
            <a:gdLst/>
            <a:ahLst/>
            <a:rect l="l" t="t" r="r" b="b"/>
            <a:pathLst>
              <a:path w="62" h="180">
                <a:moveTo>
                  <a:pt x="0" y="0"/>
                </a:moveTo>
                <a:lnTo>
                  <a:pt x="0" y="180"/>
                </a:lnTo>
                <a:lnTo>
                  <a:pt x="62" y="18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765520" y="1741320"/>
            <a:ext cx="153720" cy="405000"/>
          </a:xfrm>
          <a:custGeom>
            <a:avLst/>
            <a:gdLst/>
            <a:ahLst/>
            <a:rect l="l" t="t" r="r" b="b"/>
            <a:pathLst>
              <a:path w="97" h="255">
                <a:moveTo>
                  <a:pt x="0" y="255"/>
                </a:moveTo>
                <a:lnTo>
                  <a:pt x="0" y="0"/>
                </a:lnTo>
                <a:lnTo>
                  <a:pt x="9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182040" y="233208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846520" y="2401920"/>
            <a:ext cx="331560" cy="154080"/>
          </a:xfrm>
          <a:custGeom>
            <a:avLst/>
            <a:gdLst/>
            <a:ahLst/>
            <a:rect l="l" t="t" r="r" b="b"/>
            <a:pathLst>
              <a:path w="209" h="97">
                <a:moveTo>
                  <a:pt x="0" y="97"/>
                </a:moveTo>
                <a:lnTo>
                  <a:pt x="0" y="0"/>
                </a:lnTo>
                <a:lnTo>
                  <a:pt x="209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415040" y="254304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940200" y="2612880"/>
            <a:ext cx="471600" cy="100080"/>
          </a:xfrm>
          <a:custGeom>
            <a:avLst/>
            <a:gdLst/>
            <a:ahLst/>
            <a:rect l="l" t="t" r="r" b="b"/>
            <a:pathLst>
              <a:path w="297" h="63">
                <a:moveTo>
                  <a:pt x="0" y="63"/>
                </a:moveTo>
                <a:lnTo>
                  <a:pt x="0" y="0"/>
                </a:lnTo>
                <a:lnTo>
                  <a:pt x="29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378680" y="27543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940200" y="2722680"/>
            <a:ext cx="436680" cy="101520"/>
          </a:xfrm>
          <a:custGeom>
            <a:avLst/>
            <a:gdLst/>
            <a:ahLst/>
            <a:rect l="l" t="t" r="r" b="b"/>
            <a:pathLst>
              <a:path w="274" h="64">
                <a:moveTo>
                  <a:pt x="0" y="0"/>
                </a:moveTo>
                <a:lnTo>
                  <a:pt x="0" y="64"/>
                </a:lnTo>
                <a:lnTo>
                  <a:pt x="274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46520" y="2563920"/>
            <a:ext cx="1093680" cy="153720"/>
          </a:xfrm>
          <a:custGeom>
            <a:avLst/>
            <a:gdLst/>
            <a:ahLst/>
            <a:rect l="l" t="t" r="r" b="b"/>
            <a:pathLst>
              <a:path w="689" h="97">
                <a:moveTo>
                  <a:pt x="0" y="0"/>
                </a:moveTo>
                <a:lnTo>
                  <a:pt x="0" y="97"/>
                </a:lnTo>
                <a:lnTo>
                  <a:pt x="689" y="9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765520" y="2154240"/>
            <a:ext cx="81000" cy="404640"/>
          </a:xfrm>
          <a:custGeom>
            <a:avLst/>
            <a:gdLst/>
            <a:ahLst/>
            <a:rect l="l" t="t" r="r" b="b"/>
            <a:pathLst>
              <a:path w="51" h="255">
                <a:moveTo>
                  <a:pt x="0" y="0"/>
                </a:moveTo>
                <a:lnTo>
                  <a:pt x="0" y="255"/>
                </a:lnTo>
                <a:lnTo>
                  <a:pt x="51" y="255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230800" y="1287360"/>
            <a:ext cx="47520" cy="1594080"/>
          </a:xfrm>
          <a:custGeom>
            <a:avLst/>
            <a:gdLst/>
            <a:ahLst/>
            <a:rect l="l" t="t" r="r" b="b"/>
            <a:pathLst>
              <a:path w="30" h="1004">
                <a:moveTo>
                  <a:pt x="0" y="0"/>
                </a:moveTo>
                <a:lnTo>
                  <a:pt x="30" y="0"/>
                </a:lnTo>
                <a:lnTo>
                  <a:pt x="30" y="1004"/>
                </a:lnTo>
                <a:lnTo>
                  <a:pt x="0" y="100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389200" y="202896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Mpe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27120" y="2143080"/>
            <a:ext cx="1224000" cy="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967120" y="296532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892600" y="3035160"/>
            <a:ext cx="74520" cy="100080"/>
          </a:xfrm>
          <a:custGeom>
            <a:avLst/>
            <a:gdLst/>
            <a:ahLst/>
            <a:rect l="l" t="t" r="r" b="b"/>
            <a:pathLst>
              <a:path w="46" h="63">
                <a:moveTo>
                  <a:pt x="0" y="63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991240" y="317664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892600" y="3144960"/>
            <a:ext cx="95040" cy="101520"/>
          </a:xfrm>
          <a:custGeom>
            <a:avLst/>
            <a:gdLst/>
            <a:ahLst/>
            <a:rect l="l" t="t" r="r" b="b"/>
            <a:pathLst>
              <a:path w="60" h="64">
                <a:moveTo>
                  <a:pt x="0" y="0"/>
                </a:moveTo>
                <a:lnTo>
                  <a:pt x="0" y="64"/>
                </a:lnTo>
                <a:lnTo>
                  <a:pt x="60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714760" y="3139920"/>
            <a:ext cx="177840" cy="285840"/>
          </a:xfrm>
          <a:custGeom>
            <a:avLst/>
            <a:gdLst/>
            <a:ahLst/>
            <a:rect l="l" t="t" r="r" b="b"/>
            <a:pathLst>
              <a:path w="112" h="180">
                <a:moveTo>
                  <a:pt x="0" y="180"/>
                </a:moveTo>
                <a:lnTo>
                  <a:pt x="0" y="0"/>
                </a:lnTo>
                <a:lnTo>
                  <a:pt x="11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115080" y="33876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862360" y="3457440"/>
            <a:ext cx="250560" cy="101880"/>
          </a:xfrm>
          <a:custGeom>
            <a:avLst/>
            <a:gdLst/>
            <a:ahLst/>
            <a:rect l="l" t="t" r="r" b="b"/>
            <a:pathLst>
              <a:path w="158" h="64">
                <a:moveTo>
                  <a:pt x="0" y="64"/>
                </a:moveTo>
                <a:lnTo>
                  <a:pt x="0" y="0"/>
                </a:lnTo>
                <a:lnTo>
                  <a:pt x="158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935800" y="359892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862360" y="3567240"/>
            <a:ext cx="69840" cy="101520"/>
          </a:xfrm>
          <a:custGeom>
            <a:avLst/>
            <a:gdLst/>
            <a:ahLst/>
            <a:rect l="l" t="t" r="r" b="b"/>
            <a:pathLst>
              <a:path w="44" h="64">
                <a:moveTo>
                  <a:pt x="0" y="0"/>
                </a:moveTo>
                <a:lnTo>
                  <a:pt x="0" y="64"/>
                </a:lnTo>
                <a:lnTo>
                  <a:pt x="44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765520" y="3562200"/>
            <a:ext cx="96840" cy="154080"/>
          </a:xfrm>
          <a:custGeom>
            <a:avLst/>
            <a:gdLst/>
            <a:ahLst/>
            <a:rect l="l" t="t" r="r" b="b"/>
            <a:pathLst>
              <a:path w="61" h="97">
                <a:moveTo>
                  <a:pt x="0" y="97"/>
                </a:moveTo>
                <a:lnTo>
                  <a:pt x="0" y="0"/>
                </a:lnTo>
                <a:lnTo>
                  <a:pt x="61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998080" y="380988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765520" y="3726000"/>
            <a:ext cx="228600" cy="153720"/>
          </a:xfrm>
          <a:custGeom>
            <a:avLst/>
            <a:gdLst/>
            <a:ahLst/>
            <a:rect l="l" t="t" r="r" b="b"/>
            <a:pathLst>
              <a:path w="144" h="97">
                <a:moveTo>
                  <a:pt x="0" y="0"/>
                </a:moveTo>
                <a:lnTo>
                  <a:pt x="0" y="97"/>
                </a:lnTo>
                <a:lnTo>
                  <a:pt x="144" y="9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14760" y="3435480"/>
            <a:ext cx="50760" cy="285480"/>
          </a:xfrm>
          <a:custGeom>
            <a:avLst/>
            <a:gdLst/>
            <a:ahLst/>
            <a:rect l="l" t="t" r="r" b="b"/>
            <a:pathLst>
              <a:path w="32" h="180">
                <a:moveTo>
                  <a:pt x="0" y="0"/>
                </a:moveTo>
                <a:lnTo>
                  <a:pt x="0" y="180"/>
                </a:lnTo>
                <a:lnTo>
                  <a:pt x="32" y="18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303640" y="3430440"/>
            <a:ext cx="411120" cy="378000"/>
          </a:xfrm>
          <a:custGeom>
            <a:avLst/>
            <a:gdLst/>
            <a:ahLst/>
            <a:rect l="l" t="t" r="r" b="b"/>
            <a:pathLst>
              <a:path w="259" h="238">
                <a:moveTo>
                  <a:pt x="0" y="238"/>
                </a:moveTo>
                <a:lnTo>
                  <a:pt x="0" y="0"/>
                </a:lnTo>
                <a:lnTo>
                  <a:pt x="259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668680" y="402120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503440" y="4091040"/>
            <a:ext cx="162000" cy="101520"/>
          </a:xfrm>
          <a:custGeom>
            <a:avLst/>
            <a:gdLst/>
            <a:ahLst/>
            <a:rect l="l" t="t" r="r" b="b"/>
            <a:pathLst>
              <a:path w="102" h="64">
                <a:moveTo>
                  <a:pt x="0" y="64"/>
                </a:moveTo>
                <a:lnTo>
                  <a:pt x="0" y="0"/>
                </a:lnTo>
                <a:lnTo>
                  <a:pt x="10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756520" y="42321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503440" y="4200480"/>
            <a:ext cx="247680" cy="101520"/>
          </a:xfrm>
          <a:custGeom>
            <a:avLst/>
            <a:gdLst/>
            <a:ahLst/>
            <a:rect l="l" t="t" r="r" b="b"/>
            <a:pathLst>
              <a:path w="156" h="64">
                <a:moveTo>
                  <a:pt x="0" y="0"/>
                </a:moveTo>
                <a:lnTo>
                  <a:pt x="0" y="64"/>
                </a:lnTo>
                <a:lnTo>
                  <a:pt x="156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303640" y="3817800"/>
            <a:ext cx="199800" cy="378000"/>
          </a:xfrm>
          <a:custGeom>
            <a:avLst/>
            <a:gdLst/>
            <a:ahLst/>
            <a:rect l="l" t="t" r="r" b="b"/>
            <a:pathLst>
              <a:path w="126" h="238">
                <a:moveTo>
                  <a:pt x="0" y="0"/>
                </a:moveTo>
                <a:lnTo>
                  <a:pt x="0" y="238"/>
                </a:lnTo>
                <a:lnTo>
                  <a:pt x="126" y="238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876840" y="2978280"/>
            <a:ext cx="90360" cy="1380960"/>
          </a:xfrm>
          <a:custGeom>
            <a:avLst/>
            <a:gdLst/>
            <a:ahLst/>
            <a:rect l="l" t="t" r="r" b="b"/>
            <a:pathLst>
              <a:path w="30" h="870">
                <a:moveTo>
                  <a:pt x="0" y="0"/>
                </a:moveTo>
                <a:lnTo>
                  <a:pt x="30" y="0"/>
                </a:lnTo>
                <a:lnTo>
                  <a:pt x="30" y="870"/>
                </a:lnTo>
                <a:lnTo>
                  <a:pt x="0" y="87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133880" y="3613320"/>
            <a:ext cx="355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MS Sans Serif"/>
              </a:rPr>
              <a:t>Mp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33600" y="3813120"/>
            <a:ext cx="770040" cy="180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528920" y="2151000"/>
            <a:ext cx="2880" cy="82728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528920" y="2986200"/>
            <a:ext cx="2880" cy="82692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211400" y="2981160"/>
            <a:ext cx="317520" cy="1211400"/>
          </a:xfrm>
          <a:custGeom>
            <a:avLst/>
            <a:gdLst/>
            <a:ahLst/>
            <a:rect l="l" t="t" r="r" b="b"/>
            <a:pathLst>
              <a:path w="200" h="763">
                <a:moveTo>
                  <a:pt x="0" y="763"/>
                </a:moveTo>
                <a:lnTo>
                  <a:pt x="0" y="0"/>
                </a:lnTo>
                <a:lnTo>
                  <a:pt x="200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056760" y="444348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287440" y="4513320"/>
            <a:ext cx="765360" cy="101520"/>
          </a:xfrm>
          <a:custGeom>
            <a:avLst/>
            <a:gdLst/>
            <a:ahLst/>
            <a:rect l="l" t="t" r="r" b="b"/>
            <a:pathLst>
              <a:path w="482" h="64">
                <a:moveTo>
                  <a:pt x="0" y="64"/>
                </a:moveTo>
                <a:lnTo>
                  <a:pt x="0" y="0"/>
                </a:lnTo>
                <a:lnTo>
                  <a:pt x="48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245400" y="465444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287440" y="4622760"/>
            <a:ext cx="952560" cy="101520"/>
          </a:xfrm>
          <a:custGeom>
            <a:avLst/>
            <a:gdLst/>
            <a:ahLst/>
            <a:rect l="l" t="t" r="r" b="b"/>
            <a:pathLst>
              <a:path w="600" h="64">
                <a:moveTo>
                  <a:pt x="0" y="0"/>
                </a:moveTo>
                <a:lnTo>
                  <a:pt x="0" y="64"/>
                </a:lnTo>
                <a:lnTo>
                  <a:pt x="600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768320" y="4618080"/>
            <a:ext cx="519120" cy="790560"/>
          </a:xfrm>
          <a:custGeom>
            <a:avLst/>
            <a:gdLst/>
            <a:ahLst/>
            <a:rect l="l" t="t" r="r" b="b"/>
            <a:pathLst>
              <a:path w="327" h="498">
                <a:moveTo>
                  <a:pt x="0" y="498"/>
                </a:moveTo>
                <a:lnTo>
                  <a:pt x="0" y="0"/>
                </a:lnTo>
                <a:lnTo>
                  <a:pt x="32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419720" y="486576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251240" y="4935600"/>
            <a:ext cx="163440" cy="101520"/>
          </a:xfrm>
          <a:custGeom>
            <a:avLst/>
            <a:gdLst/>
            <a:ahLst/>
            <a:rect l="l" t="t" r="r" b="b"/>
            <a:pathLst>
              <a:path w="103" h="64">
                <a:moveTo>
                  <a:pt x="0" y="64"/>
                </a:moveTo>
                <a:lnTo>
                  <a:pt x="0" y="0"/>
                </a:lnTo>
                <a:lnTo>
                  <a:pt x="103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318560" y="507672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251240" y="5045040"/>
            <a:ext cx="61920" cy="101520"/>
          </a:xfrm>
          <a:custGeom>
            <a:avLst/>
            <a:gdLst/>
            <a:ahLst/>
            <a:rect l="l" t="t" r="r" b="b"/>
            <a:pathLst>
              <a:path w="39" h="64">
                <a:moveTo>
                  <a:pt x="0" y="0"/>
                </a:moveTo>
                <a:lnTo>
                  <a:pt x="0" y="64"/>
                </a:lnTo>
                <a:lnTo>
                  <a:pt x="39" y="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316320" y="5041800"/>
            <a:ext cx="934920" cy="154080"/>
          </a:xfrm>
          <a:custGeom>
            <a:avLst/>
            <a:gdLst/>
            <a:ahLst/>
            <a:rect l="l" t="t" r="r" b="b"/>
            <a:pathLst>
              <a:path w="590" h="97">
                <a:moveTo>
                  <a:pt x="0" y="97"/>
                </a:moveTo>
                <a:lnTo>
                  <a:pt x="0" y="0"/>
                </a:lnTo>
                <a:lnTo>
                  <a:pt x="590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074120" y="528804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316320" y="5203800"/>
            <a:ext cx="755640" cy="154080"/>
          </a:xfrm>
          <a:custGeom>
            <a:avLst/>
            <a:gdLst/>
            <a:ahLst/>
            <a:rect l="l" t="t" r="r" b="b"/>
            <a:pathLst>
              <a:path w="477" h="97">
                <a:moveTo>
                  <a:pt x="0" y="0"/>
                </a:moveTo>
                <a:lnTo>
                  <a:pt x="0" y="97"/>
                </a:lnTo>
                <a:lnTo>
                  <a:pt x="477" y="9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208240" y="5199120"/>
            <a:ext cx="1108080" cy="181080"/>
          </a:xfrm>
          <a:custGeom>
            <a:avLst/>
            <a:gdLst/>
            <a:ahLst/>
            <a:rect l="l" t="t" r="r" b="b"/>
            <a:pathLst>
              <a:path w="697" h="114">
                <a:moveTo>
                  <a:pt x="0" y="114"/>
                </a:moveTo>
                <a:lnTo>
                  <a:pt x="0" y="0"/>
                </a:lnTo>
                <a:lnTo>
                  <a:pt x="69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778560" y="549900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208240" y="5389560"/>
            <a:ext cx="1566720" cy="179280"/>
          </a:xfrm>
          <a:custGeom>
            <a:avLst/>
            <a:gdLst/>
            <a:ahLst/>
            <a:rect l="l" t="t" r="r" b="b"/>
            <a:pathLst>
              <a:path w="987" h="113">
                <a:moveTo>
                  <a:pt x="0" y="0"/>
                </a:moveTo>
                <a:lnTo>
                  <a:pt x="0" y="113"/>
                </a:lnTo>
                <a:lnTo>
                  <a:pt x="987" y="11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951200" y="5383080"/>
            <a:ext cx="252360" cy="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570840" y="571032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338640" y="5780160"/>
            <a:ext cx="228600" cy="101520"/>
          </a:xfrm>
          <a:custGeom>
            <a:avLst/>
            <a:gdLst/>
            <a:ahLst/>
            <a:rect l="l" t="t" r="r" b="b"/>
            <a:pathLst>
              <a:path w="144" h="64">
                <a:moveTo>
                  <a:pt x="0" y="64"/>
                </a:moveTo>
                <a:lnTo>
                  <a:pt x="0" y="0"/>
                </a:lnTo>
                <a:lnTo>
                  <a:pt x="144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449880" y="592128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338640" y="5891040"/>
            <a:ext cx="108000" cy="100080"/>
          </a:xfrm>
          <a:custGeom>
            <a:avLst/>
            <a:gdLst/>
            <a:ahLst/>
            <a:rect l="l" t="t" r="r" b="b"/>
            <a:pathLst>
              <a:path w="68" h="63">
                <a:moveTo>
                  <a:pt x="0" y="0"/>
                </a:moveTo>
                <a:lnTo>
                  <a:pt x="0" y="63"/>
                </a:lnTo>
                <a:lnTo>
                  <a:pt x="68" y="6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154320" y="5886360"/>
            <a:ext cx="184320" cy="154080"/>
          </a:xfrm>
          <a:custGeom>
            <a:avLst/>
            <a:gdLst/>
            <a:ahLst/>
            <a:rect l="l" t="t" r="r" b="b"/>
            <a:pathLst>
              <a:path w="116" h="97">
                <a:moveTo>
                  <a:pt x="0" y="97"/>
                </a:moveTo>
                <a:lnTo>
                  <a:pt x="0" y="0"/>
                </a:lnTo>
                <a:lnTo>
                  <a:pt x="116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432600" y="613260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154320" y="6048360"/>
            <a:ext cx="276120" cy="154080"/>
          </a:xfrm>
          <a:custGeom>
            <a:avLst/>
            <a:gdLst/>
            <a:ahLst/>
            <a:rect l="l" t="t" r="r" b="b"/>
            <a:pathLst>
              <a:path w="173" h="97">
                <a:moveTo>
                  <a:pt x="0" y="0"/>
                </a:moveTo>
                <a:lnTo>
                  <a:pt x="0" y="97"/>
                </a:lnTo>
                <a:lnTo>
                  <a:pt x="173" y="9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057480" y="6045120"/>
            <a:ext cx="96840" cy="231840"/>
          </a:xfrm>
          <a:custGeom>
            <a:avLst/>
            <a:gdLst/>
            <a:ahLst/>
            <a:rect l="l" t="t" r="r" b="b"/>
            <a:pathLst>
              <a:path w="61" h="146">
                <a:moveTo>
                  <a:pt x="0" y="146"/>
                </a:moveTo>
                <a:lnTo>
                  <a:pt x="0" y="0"/>
                </a:lnTo>
                <a:lnTo>
                  <a:pt x="61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308760" y="63435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189240" y="6413400"/>
            <a:ext cx="114480" cy="101880"/>
          </a:xfrm>
          <a:custGeom>
            <a:avLst/>
            <a:gdLst/>
            <a:ahLst/>
            <a:rect l="l" t="t" r="r" b="b"/>
            <a:pathLst>
              <a:path w="72" h="64">
                <a:moveTo>
                  <a:pt x="0" y="64"/>
                </a:moveTo>
                <a:lnTo>
                  <a:pt x="0" y="0"/>
                </a:lnTo>
                <a:lnTo>
                  <a:pt x="7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194280" y="655488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189240" y="6524640"/>
            <a:ext cx="1800" cy="100080"/>
          </a:xfrm>
          <a:custGeom>
            <a:avLst/>
            <a:gdLst/>
            <a:ahLst/>
            <a:rect l="l" t="t" r="r" b="b"/>
            <a:pathLst>
              <a:path w="0" h="63">
                <a:moveTo>
                  <a:pt x="0" y="0"/>
                </a:moveTo>
                <a:lnTo>
                  <a:pt x="0" y="63"/>
                </a:lnTo>
                <a:lnTo>
                  <a:pt x="0" y="6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057480" y="6286680"/>
            <a:ext cx="131760" cy="233280"/>
          </a:xfrm>
          <a:custGeom>
            <a:avLst/>
            <a:gdLst/>
            <a:ahLst/>
            <a:rect l="l" t="t" r="r" b="b"/>
            <a:pathLst>
              <a:path w="83" h="147">
                <a:moveTo>
                  <a:pt x="0" y="0"/>
                </a:moveTo>
                <a:lnTo>
                  <a:pt x="0" y="147"/>
                </a:lnTo>
                <a:lnTo>
                  <a:pt x="83" y="14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973240" y="6281640"/>
            <a:ext cx="84240" cy="273240"/>
          </a:xfrm>
          <a:custGeom>
            <a:avLst/>
            <a:gdLst/>
            <a:ahLst/>
            <a:rect l="l" t="t" r="r" b="b"/>
            <a:pathLst>
              <a:path w="53" h="172">
                <a:moveTo>
                  <a:pt x="0" y="172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261240" y="676584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973240" y="6564240"/>
            <a:ext cx="285840" cy="271440"/>
          </a:xfrm>
          <a:custGeom>
            <a:avLst/>
            <a:gdLst/>
            <a:ahLst/>
            <a:rect l="l" t="t" r="r" b="b"/>
            <a:pathLst>
              <a:path w="179" h="171">
                <a:moveTo>
                  <a:pt x="0" y="0"/>
                </a:moveTo>
                <a:lnTo>
                  <a:pt x="0" y="171"/>
                </a:lnTo>
                <a:lnTo>
                  <a:pt x="179" y="171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859120" y="6559560"/>
            <a:ext cx="114120" cy="239760"/>
          </a:xfrm>
          <a:custGeom>
            <a:avLst/>
            <a:gdLst/>
            <a:ahLst/>
            <a:rect l="l" t="t" r="r" b="b"/>
            <a:pathLst>
              <a:path w="72" h="151">
                <a:moveTo>
                  <a:pt x="0" y="151"/>
                </a:moveTo>
                <a:lnTo>
                  <a:pt x="0" y="0"/>
                </a:lnTo>
                <a:lnTo>
                  <a:pt x="7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056760" y="697716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859120" y="6807240"/>
            <a:ext cx="193680" cy="239760"/>
          </a:xfrm>
          <a:custGeom>
            <a:avLst/>
            <a:gdLst/>
            <a:ahLst/>
            <a:rect l="l" t="t" r="r" b="b"/>
            <a:pathLst>
              <a:path w="122" h="151">
                <a:moveTo>
                  <a:pt x="0" y="0"/>
                </a:moveTo>
                <a:lnTo>
                  <a:pt x="0" y="151"/>
                </a:lnTo>
                <a:lnTo>
                  <a:pt x="122" y="151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100240" y="6804000"/>
            <a:ext cx="758880" cy="222120"/>
          </a:xfrm>
          <a:custGeom>
            <a:avLst/>
            <a:gdLst/>
            <a:ahLst/>
            <a:rect l="l" t="t" r="r" b="b"/>
            <a:pathLst>
              <a:path w="478" h="140">
                <a:moveTo>
                  <a:pt x="0" y="140"/>
                </a:moveTo>
                <a:lnTo>
                  <a:pt x="0" y="0"/>
                </a:lnTo>
                <a:lnTo>
                  <a:pt x="478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660760" y="718992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100240" y="7034040"/>
            <a:ext cx="557280" cy="223920"/>
          </a:xfrm>
          <a:custGeom>
            <a:avLst/>
            <a:gdLst/>
            <a:ahLst/>
            <a:rect l="l" t="t" r="r" b="b"/>
            <a:pathLst>
              <a:path w="351" h="141">
                <a:moveTo>
                  <a:pt x="0" y="0"/>
                </a:moveTo>
                <a:lnTo>
                  <a:pt x="0" y="141"/>
                </a:lnTo>
                <a:lnTo>
                  <a:pt x="351" y="141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351320" y="5722920"/>
            <a:ext cx="47520" cy="1593720"/>
          </a:xfrm>
          <a:custGeom>
            <a:avLst/>
            <a:gdLst/>
            <a:ahLst/>
            <a:rect l="l" t="t" r="r" b="b"/>
            <a:pathLst>
              <a:path w="30" h="1004">
                <a:moveTo>
                  <a:pt x="0" y="0"/>
                </a:moveTo>
                <a:lnTo>
                  <a:pt x="30" y="0"/>
                </a:lnTo>
                <a:lnTo>
                  <a:pt x="30" y="1004"/>
                </a:lnTo>
                <a:lnTo>
                  <a:pt x="0" y="100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508640" y="6354720"/>
            <a:ext cx="1285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PEII linker-li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N-terminus of Mp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957320" y="7029360"/>
            <a:ext cx="142920" cy="180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951200" y="5384880"/>
            <a:ext cx="1440" cy="81756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951200" y="6211800"/>
            <a:ext cx="1440" cy="81756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768320" y="5418000"/>
            <a:ext cx="182880" cy="789120"/>
          </a:xfrm>
          <a:custGeom>
            <a:avLst/>
            <a:gdLst/>
            <a:ahLst/>
            <a:rect l="l" t="t" r="r" b="b"/>
            <a:pathLst>
              <a:path w="115" h="497">
                <a:moveTo>
                  <a:pt x="0" y="0"/>
                </a:moveTo>
                <a:lnTo>
                  <a:pt x="0" y="497"/>
                </a:lnTo>
                <a:lnTo>
                  <a:pt x="115" y="49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211400" y="4200480"/>
            <a:ext cx="556920" cy="1212840"/>
          </a:xfrm>
          <a:custGeom>
            <a:avLst/>
            <a:gdLst/>
            <a:ahLst/>
            <a:rect l="l" t="t" r="r" b="b"/>
            <a:pathLst>
              <a:path w="351" h="764">
                <a:moveTo>
                  <a:pt x="0" y="0"/>
                </a:moveTo>
                <a:lnTo>
                  <a:pt x="0" y="764"/>
                </a:lnTo>
                <a:lnTo>
                  <a:pt x="351" y="76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103120" y="422100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5/99/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731680" y="331956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4/81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515680" y="373680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44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386080" y="300204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9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272320" y="3281400"/>
            <a:ext cx="41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7/100/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819440" y="384480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9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746440" y="130500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939760" y="165420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4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769840" y="205272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5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657160" y="159552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5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451320" y="273996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8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603160" y="257652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9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316600" y="2004840"/>
            <a:ext cx="41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1/100/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833560" y="575784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763360" y="59151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3/53/4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075120" y="624996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9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665080" y="61466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3/55/2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633040" y="64231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39/33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469240" y="6661080"/>
            <a:ext cx="348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3/100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775880" y="70675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38/-/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699720" y="490212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745720" y="5048280"/>
            <a:ext cx="520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952280" y="5241960"/>
            <a:ext cx="226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36/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618560" y="623268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26/56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840320" y="4473720"/>
            <a:ext cx="419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7/100/9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657440" y="7553160"/>
            <a:ext cx="468360" cy="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652760" y="7520040"/>
            <a:ext cx="1440" cy="7128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128680" y="7520040"/>
            <a:ext cx="1800" cy="7128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823760" y="7604280"/>
            <a:ext cx="14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878280" y="4446720"/>
            <a:ext cx="88920" cy="322200"/>
          </a:xfrm>
          <a:custGeom>
            <a:avLst/>
            <a:gdLst/>
            <a:ahLst/>
            <a:rect l="l" t="t" r="r" b="b"/>
            <a:pathLst>
              <a:path w="30" h="870">
                <a:moveTo>
                  <a:pt x="0" y="0"/>
                </a:moveTo>
                <a:lnTo>
                  <a:pt x="30" y="0"/>
                </a:lnTo>
                <a:lnTo>
                  <a:pt x="30" y="870"/>
                </a:lnTo>
                <a:lnTo>
                  <a:pt x="0" y="87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4141440" y="4533840"/>
            <a:ext cx="36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Mpe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4981680" y="4886280"/>
            <a:ext cx="88920" cy="503280"/>
          </a:xfrm>
          <a:custGeom>
            <a:avLst/>
            <a:gdLst/>
            <a:ahLst/>
            <a:rect l="l" t="t" r="r" b="b"/>
            <a:pathLst>
              <a:path w="30" h="870">
                <a:moveTo>
                  <a:pt x="0" y="0"/>
                </a:moveTo>
                <a:lnTo>
                  <a:pt x="30" y="0"/>
                </a:lnTo>
                <a:lnTo>
                  <a:pt x="30" y="870"/>
                </a:lnTo>
                <a:lnTo>
                  <a:pt x="0" y="87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5192280" y="502920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Mpe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254240" y="542916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00/100/8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4932360" y="2532240"/>
            <a:ext cx="142920" cy="14112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706920" y="2320920"/>
            <a:ext cx="141120" cy="14112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933720" y="2104920"/>
            <a:ext cx="14148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869000" y="2736720"/>
            <a:ext cx="14112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"/>
          <p:cNvGrpSpPr/>
          <p:nvPr/>
        </p:nvGrpSpPr>
        <p:grpSpPr>
          <a:xfrm>
            <a:off x="3733920" y="1265400"/>
            <a:ext cx="144360" cy="142920"/>
            <a:chOff x="3733920" y="1265400"/>
            <a:chExt cx="144360" cy="142920"/>
          </a:xfrm>
        </p:grpSpPr>
        <p:sp>
          <p:nvSpPr>
            <p:cNvPr id="176" name=""/>
            <p:cNvSpPr/>
            <p:nvPr/>
          </p:nvSpPr>
          <p:spPr>
            <a:xfrm>
              <a:off x="3733920" y="12654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3806640" y="12654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19380000">
              <a:off x="3821400" y="12988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rot="5400000">
              <a:off x="3828240" y="13114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9763200">
              <a:off x="3812040" y="13622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823920" y="13168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3834000" y="13168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3806640" y="12654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834000" y="13485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3806640" y="13690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834000" y="1349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808800" y="13701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8" name=""/>
          <p:cNvGrpSpPr/>
          <p:nvPr/>
        </p:nvGrpSpPr>
        <p:grpSpPr>
          <a:xfrm>
            <a:off x="3789360" y="1465200"/>
            <a:ext cx="144360" cy="142920"/>
            <a:chOff x="3789360" y="1465200"/>
            <a:chExt cx="144360" cy="142920"/>
          </a:xfrm>
        </p:grpSpPr>
        <p:sp>
          <p:nvSpPr>
            <p:cNvPr id="189" name=""/>
            <p:cNvSpPr/>
            <p:nvPr/>
          </p:nvSpPr>
          <p:spPr>
            <a:xfrm>
              <a:off x="3789360" y="14652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862080" y="14652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rot="19380000">
              <a:off x="3876840" y="14986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rot="5400000">
              <a:off x="3883680" y="15112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rot="9763200">
              <a:off x="3867480" y="15620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879360" y="15166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V="1">
              <a:off x="3889440" y="15166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3862080" y="14652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889440" y="15483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862080" y="15688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889440" y="1549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864240" y="15699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1" name=""/>
          <p:cNvGrpSpPr/>
          <p:nvPr/>
        </p:nvGrpSpPr>
        <p:grpSpPr>
          <a:xfrm>
            <a:off x="4105440" y="1685880"/>
            <a:ext cx="144360" cy="142920"/>
            <a:chOff x="4105440" y="1685880"/>
            <a:chExt cx="144360" cy="142920"/>
          </a:xfrm>
        </p:grpSpPr>
        <p:sp>
          <p:nvSpPr>
            <p:cNvPr id="202" name=""/>
            <p:cNvSpPr/>
            <p:nvPr/>
          </p:nvSpPr>
          <p:spPr>
            <a:xfrm>
              <a:off x="4105440" y="16858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178160" y="16858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rot="19380000">
              <a:off x="4192920" y="17193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rot="5400000">
              <a:off x="4199760" y="17319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rot="9763200">
              <a:off x="4183560" y="17827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195440" y="17373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4205520" y="17373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178160" y="16858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205520" y="17690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178160" y="17895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205520" y="17701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4180320" y="17906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4" name=""/>
          <p:cNvGrpSpPr/>
          <p:nvPr/>
        </p:nvGrpSpPr>
        <p:grpSpPr>
          <a:xfrm>
            <a:off x="4572000" y="1889280"/>
            <a:ext cx="144360" cy="142920"/>
            <a:chOff x="4572000" y="1889280"/>
            <a:chExt cx="144360" cy="142920"/>
          </a:xfrm>
        </p:grpSpPr>
        <p:sp>
          <p:nvSpPr>
            <p:cNvPr id="215" name=""/>
            <p:cNvSpPr/>
            <p:nvPr/>
          </p:nvSpPr>
          <p:spPr>
            <a:xfrm>
              <a:off x="4572000" y="18892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644720" y="18892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rot="19380000">
              <a:off x="4659480" y="19227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rot="5400000">
              <a:off x="4666320" y="19353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rot="9763200">
              <a:off x="4650120" y="19861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662000" y="19407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4672080" y="19407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4644720" y="18892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672080" y="1972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644720" y="19929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672080" y="19735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646880" y="19940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7" name=""/>
          <p:cNvSpPr/>
          <p:nvPr/>
        </p:nvSpPr>
        <p:spPr>
          <a:xfrm>
            <a:off x="3510000" y="3794040"/>
            <a:ext cx="141120" cy="14148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198960" y="401004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246480" y="421164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0" name=""/>
          <p:cNvGrpSpPr/>
          <p:nvPr/>
        </p:nvGrpSpPr>
        <p:grpSpPr>
          <a:xfrm>
            <a:off x="3376440" y="2949480"/>
            <a:ext cx="144720" cy="142920"/>
            <a:chOff x="3376440" y="2949480"/>
            <a:chExt cx="144720" cy="142920"/>
          </a:xfrm>
        </p:grpSpPr>
        <p:sp>
          <p:nvSpPr>
            <p:cNvPr id="231" name=""/>
            <p:cNvSpPr/>
            <p:nvPr/>
          </p:nvSpPr>
          <p:spPr>
            <a:xfrm>
              <a:off x="3376440" y="2949480"/>
              <a:ext cx="14472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449520" y="29494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rot="19380000">
              <a:off x="3464280" y="29829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rot="5400000">
              <a:off x="3471120" y="299520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rot="9763200">
              <a:off x="3454920" y="30463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466440" y="30009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3476520" y="30009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449520" y="29494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476520" y="3032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449520" y="30531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3476520" y="30337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3451680" y="3054240"/>
              <a:ext cx="4104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3" name=""/>
          <p:cNvGrpSpPr/>
          <p:nvPr/>
        </p:nvGrpSpPr>
        <p:grpSpPr>
          <a:xfrm>
            <a:off x="3481560" y="3165480"/>
            <a:ext cx="144360" cy="142920"/>
            <a:chOff x="3481560" y="3165480"/>
            <a:chExt cx="144360" cy="142920"/>
          </a:xfrm>
        </p:grpSpPr>
        <p:sp>
          <p:nvSpPr>
            <p:cNvPr id="244" name=""/>
            <p:cNvSpPr/>
            <p:nvPr/>
          </p:nvSpPr>
          <p:spPr>
            <a:xfrm>
              <a:off x="3481560" y="31654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554280" y="31654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19380000">
              <a:off x="3569040" y="31989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5400000">
              <a:off x="3575880" y="32115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rot="9763200">
              <a:off x="3559680" y="32623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571560" y="32169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3581640" y="32169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554280" y="31654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581640" y="3248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554280" y="32691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581640" y="32497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3556440" y="32702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6" name=""/>
          <p:cNvGrpSpPr/>
          <p:nvPr/>
        </p:nvGrpSpPr>
        <p:grpSpPr>
          <a:xfrm>
            <a:off x="3606840" y="3376440"/>
            <a:ext cx="144360" cy="142920"/>
            <a:chOff x="3606840" y="3376440"/>
            <a:chExt cx="144360" cy="142920"/>
          </a:xfrm>
        </p:grpSpPr>
        <p:sp>
          <p:nvSpPr>
            <p:cNvPr id="257" name=""/>
            <p:cNvSpPr/>
            <p:nvPr/>
          </p:nvSpPr>
          <p:spPr>
            <a:xfrm>
              <a:off x="3606840" y="3376440"/>
              <a:ext cx="144360" cy="13500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" bIns="-1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679560" y="3376440"/>
              <a:ext cx="32760" cy="10404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rot="19380000">
              <a:off x="3694320" y="34099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rot="5400000">
              <a:off x="3701160" y="34225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rot="9763200">
              <a:off x="3684960" y="34732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696840" y="34279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3706920" y="34279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679560" y="33764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706920" y="345996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679560" y="34804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3706920" y="346068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3681720" y="3481560"/>
              <a:ext cx="40680" cy="2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9" name=""/>
          <p:cNvGrpSpPr/>
          <p:nvPr/>
        </p:nvGrpSpPr>
        <p:grpSpPr>
          <a:xfrm>
            <a:off x="3429000" y="3592440"/>
            <a:ext cx="144360" cy="142920"/>
            <a:chOff x="3429000" y="3592440"/>
            <a:chExt cx="144360" cy="142920"/>
          </a:xfrm>
        </p:grpSpPr>
        <p:sp>
          <p:nvSpPr>
            <p:cNvPr id="270" name=""/>
            <p:cNvSpPr/>
            <p:nvPr/>
          </p:nvSpPr>
          <p:spPr>
            <a:xfrm>
              <a:off x="3429000" y="359244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501720" y="359244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 rot="19380000">
              <a:off x="3516480" y="36259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rot="5400000">
              <a:off x="3523320" y="36385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rot="9763200">
              <a:off x="3507120" y="36892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519000" y="36439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flipV="1">
              <a:off x="3529080" y="36439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501720" y="35924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529080" y="36756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3501720" y="36961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529080" y="36766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503880" y="369720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2" name=""/>
          <p:cNvSpPr/>
          <p:nvPr/>
        </p:nvSpPr>
        <p:spPr>
          <a:xfrm>
            <a:off x="4302000" y="5489640"/>
            <a:ext cx="141480" cy="14112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184560" y="7169040"/>
            <a:ext cx="142920" cy="14148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573360" y="4422600"/>
            <a:ext cx="141480" cy="14148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971880" y="5900760"/>
            <a:ext cx="14148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4067280" y="5700600"/>
            <a:ext cx="14112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7" name=""/>
          <p:cNvGrpSpPr/>
          <p:nvPr/>
        </p:nvGrpSpPr>
        <p:grpSpPr>
          <a:xfrm>
            <a:off x="4811760" y="4844880"/>
            <a:ext cx="144360" cy="142920"/>
            <a:chOff x="4811760" y="4844880"/>
            <a:chExt cx="144360" cy="142920"/>
          </a:xfrm>
        </p:grpSpPr>
        <p:sp>
          <p:nvSpPr>
            <p:cNvPr id="288" name=""/>
            <p:cNvSpPr/>
            <p:nvPr/>
          </p:nvSpPr>
          <p:spPr>
            <a:xfrm>
              <a:off x="4811760" y="4844880"/>
              <a:ext cx="144360" cy="13500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40" bIns="-1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4884480" y="4844880"/>
              <a:ext cx="32760" cy="10404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rot="19380000">
              <a:off x="4899240" y="48783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rot="5400000">
              <a:off x="4906080" y="48909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rot="9763200">
              <a:off x="4889880" y="49417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901760" y="48963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flipV="1">
              <a:off x="4911840" y="48963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884480" y="48448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911840" y="492840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884480" y="49489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4911840" y="4929120"/>
              <a:ext cx="1584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4886640" y="4950000"/>
              <a:ext cx="40680" cy="29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0" name=""/>
          <p:cNvGrpSpPr/>
          <p:nvPr/>
        </p:nvGrpSpPr>
        <p:grpSpPr>
          <a:xfrm>
            <a:off x="4807080" y="5067360"/>
            <a:ext cx="144360" cy="142920"/>
            <a:chOff x="4807080" y="5067360"/>
            <a:chExt cx="144360" cy="142920"/>
          </a:xfrm>
        </p:grpSpPr>
        <p:sp>
          <p:nvSpPr>
            <p:cNvPr id="301" name=""/>
            <p:cNvSpPr/>
            <p:nvPr/>
          </p:nvSpPr>
          <p:spPr>
            <a:xfrm>
              <a:off x="4807080" y="506736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879800" y="506736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rot="19380000">
              <a:off x="4894560" y="510084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rot="5400000">
              <a:off x="4901400" y="511344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 rot="9763200">
              <a:off x="4885200" y="516420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897080" y="511884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flipV="1">
              <a:off x="4907160" y="511884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879800" y="506736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907160" y="51505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879800" y="517104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907160" y="51516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881960" y="517212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3" name=""/>
          <p:cNvGrpSpPr/>
          <p:nvPr/>
        </p:nvGrpSpPr>
        <p:grpSpPr>
          <a:xfrm>
            <a:off x="3716280" y="4643280"/>
            <a:ext cx="144360" cy="142920"/>
            <a:chOff x="3716280" y="4643280"/>
            <a:chExt cx="144360" cy="142920"/>
          </a:xfrm>
        </p:grpSpPr>
        <p:sp>
          <p:nvSpPr>
            <p:cNvPr id="314" name=""/>
            <p:cNvSpPr/>
            <p:nvPr/>
          </p:nvSpPr>
          <p:spPr>
            <a:xfrm>
              <a:off x="3716280" y="46432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3789000" y="46432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19380000">
              <a:off x="3803760" y="46767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 rot="5400000">
              <a:off x="3810600" y="46893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rot="9763200">
              <a:off x="3794400" y="47401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3806280" y="46947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flipV="1">
              <a:off x="3816360" y="46947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3789000" y="46432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816360" y="4726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789000" y="47469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816360" y="47275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3791160" y="47480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6" name=""/>
          <p:cNvGrpSpPr/>
          <p:nvPr/>
        </p:nvGrpSpPr>
        <p:grpSpPr>
          <a:xfrm>
            <a:off x="4570560" y="5273640"/>
            <a:ext cx="144360" cy="142920"/>
            <a:chOff x="4570560" y="5273640"/>
            <a:chExt cx="144360" cy="142920"/>
          </a:xfrm>
        </p:grpSpPr>
        <p:sp>
          <p:nvSpPr>
            <p:cNvPr id="327" name=""/>
            <p:cNvSpPr/>
            <p:nvPr/>
          </p:nvSpPr>
          <p:spPr>
            <a:xfrm>
              <a:off x="4570560" y="527364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643280" y="527364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rot="19380000">
              <a:off x="4658040" y="53071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rot="5400000">
              <a:off x="4664880" y="53197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 rot="9763200">
              <a:off x="4648680" y="53704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660560" y="53251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V="1">
              <a:off x="4670640" y="53251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643280" y="52736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670640" y="53568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643280" y="53773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4670640" y="53578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4645440" y="537840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39" name=""/>
          <p:cNvGrpSpPr/>
          <p:nvPr/>
        </p:nvGrpSpPr>
        <p:grpSpPr>
          <a:xfrm>
            <a:off x="3932280" y="6116760"/>
            <a:ext cx="144360" cy="142920"/>
            <a:chOff x="3932280" y="6116760"/>
            <a:chExt cx="144360" cy="142920"/>
          </a:xfrm>
        </p:grpSpPr>
        <p:sp>
          <p:nvSpPr>
            <p:cNvPr id="340" name=""/>
            <p:cNvSpPr/>
            <p:nvPr/>
          </p:nvSpPr>
          <p:spPr>
            <a:xfrm>
              <a:off x="3932280" y="611676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4005000" y="611676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rot="19380000">
              <a:off x="4019760" y="615024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rot="5400000">
              <a:off x="4026600" y="616284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 rot="9763200">
              <a:off x="4010400" y="621360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4022280" y="616824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4032360" y="616824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4005000" y="611676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4032360" y="61999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005000" y="622044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4032360" y="62010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007160" y="622152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52" name=""/>
          <p:cNvGrpSpPr/>
          <p:nvPr/>
        </p:nvGrpSpPr>
        <p:grpSpPr>
          <a:xfrm>
            <a:off x="3822840" y="6332400"/>
            <a:ext cx="144360" cy="142920"/>
            <a:chOff x="3822840" y="6332400"/>
            <a:chExt cx="144360" cy="142920"/>
          </a:xfrm>
        </p:grpSpPr>
        <p:sp>
          <p:nvSpPr>
            <p:cNvPr id="353" name=""/>
            <p:cNvSpPr/>
            <p:nvPr/>
          </p:nvSpPr>
          <p:spPr>
            <a:xfrm>
              <a:off x="3822840" y="63324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3895560" y="63324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rot="19380000">
              <a:off x="3910320" y="63658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rot="5400000">
              <a:off x="3917160" y="63784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rot="9763200">
              <a:off x="3900960" y="64292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912840" y="63838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V="1">
              <a:off x="3922920" y="63838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895560" y="63324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922920" y="64155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3895560" y="64360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922920" y="6416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897720" y="64371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5" name=""/>
          <p:cNvGrpSpPr/>
          <p:nvPr/>
        </p:nvGrpSpPr>
        <p:grpSpPr>
          <a:xfrm>
            <a:off x="3611520" y="6540480"/>
            <a:ext cx="144360" cy="142920"/>
            <a:chOff x="3611520" y="6540480"/>
            <a:chExt cx="144360" cy="142920"/>
          </a:xfrm>
        </p:grpSpPr>
        <p:sp>
          <p:nvSpPr>
            <p:cNvPr id="366" name=""/>
            <p:cNvSpPr/>
            <p:nvPr/>
          </p:nvSpPr>
          <p:spPr>
            <a:xfrm>
              <a:off x="3611520" y="65404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684240" y="65404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rot="19380000">
              <a:off x="3699000" y="65739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rot="5400000">
              <a:off x="3705840" y="65865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rot="9763200">
              <a:off x="3689640" y="66373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3701520" y="65919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 flipV="1">
              <a:off x="3711600" y="65919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3684240" y="65404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3711600" y="66236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3684240" y="66441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3711600" y="66247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686400" y="66452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8" name=""/>
          <p:cNvGrpSpPr/>
          <p:nvPr/>
        </p:nvGrpSpPr>
        <p:grpSpPr>
          <a:xfrm>
            <a:off x="3760920" y="6746760"/>
            <a:ext cx="144360" cy="142920"/>
            <a:chOff x="3760920" y="6746760"/>
            <a:chExt cx="144360" cy="142920"/>
          </a:xfrm>
        </p:grpSpPr>
        <p:sp>
          <p:nvSpPr>
            <p:cNvPr id="379" name=""/>
            <p:cNvSpPr/>
            <p:nvPr/>
          </p:nvSpPr>
          <p:spPr>
            <a:xfrm>
              <a:off x="3760920" y="674676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3833640" y="674676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rot="19380000">
              <a:off x="3848400" y="678024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rot="5400000">
              <a:off x="3855240" y="679284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rot="9763200">
              <a:off x="3839040" y="684360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3850920" y="679824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flipV="1">
              <a:off x="3861000" y="679824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3833640" y="674676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3861000" y="68299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3833640" y="685044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3861000" y="68310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835800" y="685152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1" name=""/>
          <p:cNvSpPr/>
          <p:nvPr/>
        </p:nvSpPr>
        <p:spPr>
          <a:xfrm>
            <a:off x="3573360" y="6961320"/>
            <a:ext cx="141480" cy="14112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6T13:03:32Z</dcterms:created>
  <dc:creator>Laurence Garczarek</dc:creator>
  <dc:description/>
  <dc:language>en-US</dc:language>
  <cp:lastModifiedBy>Fred Partensky</cp:lastModifiedBy>
  <dcterms:modified xsi:type="dcterms:W3CDTF">2007-11-29T15:13:30Z</dcterms:modified>
  <cp:revision>31</cp:revision>
  <dc:subject/>
  <dc:title>Diapositive 1</dc:title>
</cp:coreProperties>
</file>